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94648D-A8AD-44D0-84FF-CBD2C119429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85E10E-4846-40A8-86F9-749763B3293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161522-7EFB-426C-8490-A30FBF7E65C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8EFB59-12A9-48BE-939F-DE18407D9EB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5CABE4-7FA2-497A-8534-4E4B0B80C61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AC67DE-74DC-4D5F-BA65-1AF31C9EA2B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0F5545-5D23-458D-9977-A2C897A3040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267154-B1A7-4A5F-A849-C6E63CE66C1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454F34-8FC3-4F9D-BFAD-6E66C3A6258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A137ED-7BB3-471A-9B09-0B9A9E426D1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016D8C-CF39-4ADB-B24C-FF0CDD74B6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81D6AF-062D-49DA-987C-068EAD53F3B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90DE6F86-4424-4FD5-B44E-DD814EDAD612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6E2279C1-EC65-48C4-B812-D8992E00515F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" descr="JU1825 ant spermatheca ad A 100x LU*.bmp"/>
          <p:cNvPicPr/>
          <p:nvPr/>
        </p:nvPicPr>
        <p:blipFill>
          <a:blip r:embed="rId1"/>
          <a:stretch/>
        </p:blipFill>
        <p:spPr>
          <a:xfrm>
            <a:off x="3886200" y="4419720"/>
            <a:ext cx="2438280" cy="1828800"/>
          </a:xfrm>
          <a:prstGeom prst="rect">
            <a:avLst/>
          </a:prstGeom>
          <a:ln w="0">
            <a:noFill/>
          </a:ln>
        </p:spPr>
      </p:pic>
      <p:sp>
        <p:nvSpPr>
          <p:cNvPr id="42" name="TextBox 5"/>
          <p:cNvSpPr/>
          <p:nvPr/>
        </p:nvSpPr>
        <p:spPr>
          <a:xfrm>
            <a:off x="3886200" y="4419720"/>
            <a:ext cx="137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C.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p. 17 JU182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3" name="Picture 7" descr="JU1853 ant spermatheca ad D LU 100x*.bmp"/>
          <p:cNvPicPr/>
          <p:nvPr/>
        </p:nvPicPr>
        <p:blipFill>
          <a:blip r:embed="rId2"/>
          <a:stretch/>
        </p:blipFill>
        <p:spPr>
          <a:xfrm>
            <a:off x="3886200" y="457200"/>
            <a:ext cx="2438280" cy="1828800"/>
          </a:xfrm>
          <a:prstGeom prst="rect">
            <a:avLst/>
          </a:prstGeom>
          <a:ln w="0">
            <a:noFill/>
          </a:ln>
        </p:spPr>
      </p:pic>
      <p:sp>
        <p:nvSpPr>
          <p:cNvPr id="44" name="TextBox 8"/>
          <p:cNvSpPr/>
          <p:nvPr/>
        </p:nvSpPr>
        <p:spPr>
          <a:xfrm>
            <a:off x="3886200" y="457200"/>
            <a:ext cx="137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C.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sp. 18 JU185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5" name="Picture 12" descr="JU1857 ant spermatheca 100x ad fem B RU*.bmp"/>
          <p:cNvPicPr/>
          <p:nvPr/>
        </p:nvPicPr>
        <p:blipFill>
          <a:blip r:embed="rId3"/>
          <a:stretch/>
        </p:blipFill>
        <p:spPr>
          <a:xfrm>
            <a:off x="3886200" y="2362320"/>
            <a:ext cx="2438280" cy="1828800"/>
          </a:xfrm>
          <a:prstGeom prst="rect">
            <a:avLst/>
          </a:prstGeom>
          <a:ln w="0">
            <a:noFill/>
          </a:ln>
        </p:spPr>
      </p:pic>
      <p:sp>
        <p:nvSpPr>
          <p:cNvPr id="46" name="TextBox 13"/>
          <p:cNvSpPr/>
          <p:nvPr/>
        </p:nvSpPr>
        <p:spPr>
          <a:xfrm>
            <a:off x="3886200" y="2362320"/>
            <a:ext cx="1447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C.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sp. 18 JU185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16"/>
          <p:cNvSpPr/>
          <p:nvPr/>
        </p:nvSpPr>
        <p:spPr>
          <a:xfrm>
            <a:off x="380880" y="533520"/>
            <a:ext cx="3276720" cy="2101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Large sperm size in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Caenorhabditis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sp. 18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DIC micrographs of spermathecae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in females of two isolates of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C.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sp. 18,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howing large sperm size, in comparison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with a typical sperm size in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C.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sp. 17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All images show the anterior spermatheca, anterior side is to the left, dorsal side is up. Arrows point to sperm, "o" indicates oocytes,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asteriscs indicate fertilized oocytes (in the uterus beyond spermatheca). Same scale for all pictures. Bar: 10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m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Rectangle 17"/>
          <p:cNvSpPr/>
          <p:nvPr/>
        </p:nvSpPr>
        <p:spPr>
          <a:xfrm>
            <a:off x="6286680" y="380880"/>
            <a:ext cx="114120" cy="5943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49" name="Straight Arrow Connector 19"/>
          <p:cNvCxnSpPr/>
          <p:nvPr/>
        </p:nvCxnSpPr>
        <p:spPr>
          <a:xfrm flipV="1">
            <a:off x="4799520" y="1294560"/>
            <a:ext cx="153000" cy="2293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50" name="Straight Arrow Connector 20"/>
          <p:cNvCxnSpPr/>
          <p:nvPr/>
        </p:nvCxnSpPr>
        <p:spPr>
          <a:xfrm flipV="1">
            <a:off x="4876560" y="1447200"/>
            <a:ext cx="229320" cy="1530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51" name="Straight Arrow Connector 23"/>
          <p:cNvCxnSpPr/>
          <p:nvPr/>
        </p:nvCxnSpPr>
        <p:spPr>
          <a:xfrm flipV="1">
            <a:off x="4113720" y="3504600"/>
            <a:ext cx="153000" cy="2293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52" name="Straight Arrow Connector 24"/>
          <p:cNvCxnSpPr/>
          <p:nvPr/>
        </p:nvCxnSpPr>
        <p:spPr>
          <a:xfrm flipV="1">
            <a:off x="4190760" y="3656880"/>
            <a:ext cx="229320" cy="1530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53" name="Straight Arrow Connector 25"/>
          <p:cNvCxnSpPr/>
          <p:nvPr/>
        </p:nvCxnSpPr>
        <p:spPr>
          <a:xfrm flipV="1">
            <a:off x="4113720" y="5714280"/>
            <a:ext cx="153000" cy="2293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54" name="Straight Arrow Connector 26"/>
          <p:cNvCxnSpPr/>
          <p:nvPr/>
        </p:nvCxnSpPr>
        <p:spPr>
          <a:xfrm flipV="1">
            <a:off x="4286880" y="5757120"/>
            <a:ext cx="76680" cy="2293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55" name="TextBox 28"/>
          <p:cNvSpPr/>
          <p:nvPr/>
        </p:nvSpPr>
        <p:spPr>
          <a:xfrm>
            <a:off x="5033880" y="502920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29"/>
          <p:cNvSpPr/>
          <p:nvPr/>
        </p:nvSpPr>
        <p:spPr>
          <a:xfrm>
            <a:off x="6049800" y="297180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Straight Connector 40"/>
          <p:cNvSpPr/>
          <p:nvPr/>
        </p:nvSpPr>
        <p:spPr>
          <a:xfrm>
            <a:off x="5943600" y="6172200"/>
            <a:ext cx="228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45"/>
          <p:cNvSpPr/>
          <p:nvPr/>
        </p:nvSpPr>
        <p:spPr>
          <a:xfrm>
            <a:off x="3890520" y="3809880"/>
            <a:ext cx="26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o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46"/>
          <p:cNvSpPr/>
          <p:nvPr/>
        </p:nvSpPr>
        <p:spPr>
          <a:xfrm>
            <a:off x="3890520" y="5591160"/>
            <a:ext cx="26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o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47"/>
          <p:cNvSpPr/>
          <p:nvPr/>
        </p:nvSpPr>
        <p:spPr>
          <a:xfrm>
            <a:off x="4271400" y="1371600"/>
            <a:ext cx="26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o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3-07T23:18:58Z</dcterms:created>
  <dc:creator>Karin Kiontke</dc:creator>
  <dc:description/>
  <dc:language>en-US</dc:language>
  <cp:lastModifiedBy>Karin Kiontke</cp:lastModifiedBy>
  <dcterms:modified xsi:type="dcterms:W3CDTF">2011-09-12T18:38:08Z</dcterms:modified>
  <cp:revision>3</cp:revision>
  <dc:subject/>
  <dc:title>Slide 1</dc:title>
</cp:coreProperties>
</file>